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0" r:id="rId3"/>
    <p:sldId id="259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2628" y="-1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hD\PhD_all\PhD%20thesis\Chapter%205%20(Vib%20Trial)\Working\Pain\Done\Pain%20-%20What%20is%20the%20level%20of%20your%20shoulder%20pain%20when%20you%20sleep%202%20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hD\PhD_all\PhD%20thesis\Chapter%205%20(Vib%20Trial)\Working\Pain\Done\Pain%20-%20What%20is%20the%20level%20of%20your%20shoulder%20pain%20when%20you%20sleep%202%20a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H:\PhD\PhD%20-%20Working%20folder\Working\Pain\Done\Pain%20-%20How%20much%20difficulty%20do%20you%20have%20with%20activites%20above%20your%20hea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AU"/>
  <c:chart>
    <c:autoTitleDeleted val="1"/>
    <c:plotArea>
      <c:layout>
        <c:manualLayout>
          <c:layoutTarget val="inner"/>
          <c:xMode val="edge"/>
          <c:yMode val="edge"/>
          <c:x val="0.20017836832895874"/>
          <c:y val="9.4271912625881901E-2"/>
          <c:w val="0.7799674103237102"/>
          <c:h val="0.74587514257204579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710082752638638</c:v>
                  </c:pt>
                  <c:pt idx="1">
                    <c:v>0.17203750211522942</c:v>
                  </c:pt>
                  <c:pt idx="2">
                    <c:v>0.12950229605666971</c:v>
                  </c:pt>
                  <c:pt idx="3">
                    <c:v>0.13714218073426282</c:v>
                  </c:pt>
                  <c:pt idx="4">
                    <c:v>0.12958989523026121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710082752638638</c:v>
                  </c:pt>
                  <c:pt idx="1">
                    <c:v>0.17203750211522942</c:v>
                  </c:pt>
                  <c:pt idx="2">
                    <c:v>0.12950229605666971</c:v>
                  </c:pt>
                  <c:pt idx="3">
                    <c:v>0.13714218073426282</c:v>
                  </c:pt>
                  <c:pt idx="4">
                    <c:v>0.12958989523026121</c:v>
                  </c:pt>
                </c:numCache>
              </c:numRef>
            </c:minus>
            <c:spPr>
              <a:ln>
                <a:solidFill>
                  <a:srgbClr val="0070C0"/>
                </a:solidFill>
              </a:ln>
            </c:spPr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9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2.5806451612903225</c:v>
                </c:pt>
                <c:pt idx="1">
                  <c:v>2.032258064516125</c:v>
                </c:pt>
                <c:pt idx="2">
                  <c:v>1.8983050847457645</c:v>
                </c:pt>
                <c:pt idx="3">
                  <c:v>1.4642857142857153</c:v>
                </c:pt>
                <c:pt idx="4">
                  <c:v>0.94117647058823561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marker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2357201111106499</c:v>
                  </c:pt>
                  <c:pt idx="1">
                    <c:v>0.16087654147061742</c:v>
                  </c:pt>
                  <c:pt idx="2">
                    <c:v>0.13918988100978422</c:v>
                  </c:pt>
                  <c:pt idx="3">
                    <c:v>0.12941176470588234</c:v>
                  </c:pt>
                  <c:pt idx="4">
                    <c:v>0.1413305213218824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2357201111106499</c:v>
                  </c:pt>
                  <c:pt idx="1">
                    <c:v>0.16087654147061742</c:v>
                  </c:pt>
                  <c:pt idx="2">
                    <c:v>0.13918988100978422</c:v>
                  </c:pt>
                  <c:pt idx="3">
                    <c:v>0.12941176470588234</c:v>
                  </c:pt>
                  <c:pt idx="4">
                    <c:v>0.1413305213218824</c:v>
                  </c:pt>
                </c:numCache>
              </c:numRef>
            </c:minus>
            <c:spPr>
              <a:ln>
                <a:solidFill>
                  <a:srgbClr val="92D050"/>
                </a:solidFill>
              </a:ln>
            </c:spPr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2.4827586206896526</c:v>
                </c:pt>
                <c:pt idx="1">
                  <c:v>1.9285714285714293</c:v>
                </c:pt>
                <c:pt idx="2">
                  <c:v>1.9166666666666663</c:v>
                </c:pt>
                <c:pt idx="3">
                  <c:v>1.5294117647058822</c:v>
                </c:pt>
                <c:pt idx="4">
                  <c:v>0.97959183673469463</c:v>
                </c:pt>
              </c:numCache>
            </c:numRef>
          </c:val>
        </c:ser>
        <c:marker val="1"/>
        <c:axId val="82748160"/>
        <c:axId val="82750080"/>
      </c:lineChart>
      <c:catAx>
        <c:axId val="8274816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Weeks after Rotator Cuff Repair</a:t>
                </a:r>
              </a:p>
            </c:rich>
          </c:tx>
          <c:layout>
            <c:manualLayout>
              <c:xMode val="edge"/>
              <c:yMode val="edge"/>
              <c:x val="0.38228707349081398"/>
              <c:y val="0.92086829781629587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2750080"/>
        <c:crosses val="autoZero"/>
        <c:auto val="1"/>
        <c:lblAlgn val="ctr"/>
        <c:lblOffset val="100"/>
      </c:catAx>
      <c:valAx>
        <c:axId val="82750080"/>
        <c:scaling>
          <c:orientation val="minMax"/>
          <c:max val="4"/>
        </c:scaling>
        <c:axPos val="l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Level of Shoulder Pain during Sleep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4118152162488637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2748160"/>
        <c:crosses val="autoZero"/>
        <c:crossBetween val="between"/>
        <c:majorUnit val="1"/>
        <c:minorUnit val="1"/>
      </c:valAx>
    </c:plotArea>
    <c:legend>
      <c:legendPos val="r"/>
      <c:layout>
        <c:manualLayout>
          <c:xMode val="edge"/>
          <c:yMode val="edge"/>
          <c:x val="0.84542355643044631"/>
          <c:y val="0.72384135478153233"/>
          <c:w val="0.1351319991251094"/>
          <c:h val="0.10437441527619724"/>
        </c:manualLayout>
      </c:layout>
      <c:txPr>
        <a:bodyPr/>
        <a:lstStyle/>
        <a:p>
          <a:pPr>
            <a:defRPr sz="1600"/>
          </a:pPr>
          <a:endParaRPr lang="en-US"/>
        </a:p>
      </c:txPr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AU"/>
  <c:chart>
    <c:autoTitleDeleted val="1"/>
    <c:plotArea>
      <c:layout>
        <c:manualLayout>
          <c:layoutTarget val="inner"/>
          <c:xMode val="edge"/>
          <c:yMode val="edge"/>
          <c:x val="0.2001783683289588"/>
          <c:y val="9.4271912625881887E-2"/>
          <c:w val="0.77996741032370986"/>
          <c:h val="0.74587514257204546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710082752638638</c:v>
                  </c:pt>
                  <c:pt idx="1">
                    <c:v>0.17203750211522936</c:v>
                  </c:pt>
                  <c:pt idx="2">
                    <c:v>0.12950229605666971</c:v>
                  </c:pt>
                  <c:pt idx="3">
                    <c:v>0.13714218073426276</c:v>
                  </c:pt>
                  <c:pt idx="4">
                    <c:v>0.12958989523026121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710082752638638</c:v>
                  </c:pt>
                  <c:pt idx="1">
                    <c:v>0.17203750211522936</c:v>
                  </c:pt>
                  <c:pt idx="2">
                    <c:v>0.12950229605666971</c:v>
                  </c:pt>
                  <c:pt idx="3">
                    <c:v>0.13714218073426276</c:v>
                  </c:pt>
                  <c:pt idx="4">
                    <c:v>0.12958989523026121</c:v>
                  </c:pt>
                </c:numCache>
              </c:numRef>
            </c:minus>
            <c:spPr>
              <a:ln>
                <a:solidFill>
                  <a:srgbClr val="0070C0"/>
                </a:solidFill>
              </a:ln>
            </c:spPr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9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2.5806451612903225</c:v>
                </c:pt>
                <c:pt idx="1">
                  <c:v>2.0322580645161263</c:v>
                </c:pt>
                <c:pt idx="2">
                  <c:v>1.8983050847457641</c:v>
                </c:pt>
                <c:pt idx="3">
                  <c:v>1.4642857142857149</c:v>
                </c:pt>
                <c:pt idx="4">
                  <c:v>0.94117647058823561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2357201111106499</c:v>
                  </c:pt>
                  <c:pt idx="1">
                    <c:v>0.16087654147061745</c:v>
                  </c:pt>
                  <c:pt idx="2">
                    <c:v>0.13918988100978422</c:v>
                  </c:pt>
                  <c:pt idx="3">
                    <c:v>0.12941176470588234</c:v>
                  </c:pt>
                  <c:pt idx="4">
                    <c:v>0.14133052132188245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2357201111106499</c:v>
                  </c:pt>
                  <c:pt idx="1">
                    <c:v>0.16087654147061745</c:v>
                  </c:pt>
                  <c:pt idx="2">
                    <c:v>0.13918988100978422</c:v>
                  </c:pt>
                  <c:pt idx="3">
                    <c:v>0.12941176470588234</c:v>
                  </c:pt>
                  <c:pt idx="4">
                    <c:v>0.14133052132188245</c:v>
                  </c:pt>
                </c:numCache>
              </c:numRef>
            </c:minus>
            <c:spPr>
              <a:ln>
                <a:solidFill>
                  <a:srgbClr val="92D050"/>
                </a:solidFill>
              </a:ln>
            </c:spPr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2.4827586206896535</c:v>
                </c:pt>
                <c:pt idx="1">
                  <c:v>1.928571428571429</c:v>
                </c:pt>
                <c:pt idx="2">
                  <c:v>1.9166666666666665</c:v>
                </c:pt>
                <c:pt idx="3">
                  <c:v>1.5294117647058822</c:v>
                </c:pt>
                <c:pt idx="4">
                  <c:v>0.9795918367346943</c:v>
                </c:pt>
              </c:numCache>
            </c:numRef>
          </c:val>
        </c:ser>
        <c:marker val="1"/>
        <c:axId val="84218240"/>
        <c:axId val="84220160"/>
      </c:lineChart>
      <c:catAx>
        <c:axId val="8421824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Weeks after Rotator Cuff Repair</a:t>
                </a:r>
              </a:p>
            </c:rich>
          </c:tx>
          <c:layout>
            <c:manualLayout>
              <c:xMode val="edge"/>
              <c:yMode val="edge"/>
              <c:x val="0.38228707349081387"/>
              <c:y val="0.92086829781629587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4220160"/>
        <c:crosses val="autoZero"/>
        <c:auto val="1"/>
        <c:lblAlgn val="ctr"/>
        <c:lblOffset val="100"/>
      </c:catAx>
      <c:valAx>
        <c:axId val="84220160"/>
        <c:scaling>
          <c:orientation val="minMax"/>
          <c:max val="4"/>
        </c:scaling>
        <c:axPos val="l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Level of Shoulder Pain during Sleep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14118152162488648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4218240"/>
        <c:crosses val="autoZero"/>
        <c:crossBetween val="between"/>
        <c:majorUnit val="1"/>
        <c:minorUnit val="1"/>
      </c:valAx>
    </c:plotArea>
    <c:legend>
      <c:legendPos val="r"/>
      <c:layout>
        <c:manualLayout>
          <c:xMode val="edge"/>
          <c:yMode val="edge"/>
          <c:x val="0.83847911198600178"/>
          <c:y val="3.3769948732455042E-2"/>
          <c:w val="0.1351319991251094"/>
          <c:h val="0.10437441527619724"/>
        </c:manualLayout>
      </c:layout>
      <c:txPr>
        <a:bodyPr/>
        <a:lstStyle/>
        <a:p>
          <a:pPr>
            <a:defRPr sz="1600"/>
          </a:pPr>
          <a:endParaRPr lang="en-US"/>
        </a:p>
      </c:txPr>
    </c:legend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autoTitleDeleted val="1"/>
    <c:plotArea>
      <c:layout>
        <c:manualLayout>
          <c:layoutTarget val="inner"/>
          <c:xMode val="edge"/>
          <c:yMode val="edge"/>
          <c:x val="0.21927756020740621"/>
          <c:y val="0.19503178769320514"/>
          <c:w val="0.70073852498521849"/>
          <c:h val="0.6724406532516789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39</c:v>
                  </c:pt>
                  <c:pt idx="2">
                    <c:v>0.18538488297990471</c:v>
                  </c:pt>
                  <c:pt idx="3">
                    <c:v>0.16524355544590558</c:v>
                  </c:pt>
                  <c:pt idx="4">
                    <c:v>0.14292949787065545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39</c:v>
                  </c:pt>
                  <c:pt idx="2">
                    <c:v>0.18538488297990471</c:v>
                  </c:pt>
                  <c:pt idx="3">
                    <c:v>0.16524355544590558</c:v>
                  </c:pt>
                  <c:pt idx="4">
                    <c:v>0.14292949787065545</c:v>
                  </c:pt>
                </c:numCache>
              </c:numRef>
            </c:minus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1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3.0163934426229551</c:v>
                </c:pt>
                <c:pt idx="1">
                  <c:v>3.6744186046511627</c:v>
                </c:pt>
                <c:pt idx="2">
                  <c:v>2.7924528301886737</c:v>
                </c:pt>
                <c:pt idx="3">
                  <c:v>2.1851851851851847</c:v>
                </c:pt>
                <c:pt idx="4">
                  <c:v>1.7358490566037739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marker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19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46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19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46</c:v>
                  </c:pt>
                </c:numCache>
              </c:numRef>
            </c:minus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3.0517241379310351</c:v>
                </c:pt>
                <c:pt idx="1">
                  <c:v>3.6666666666666665</c:v>
                </c:pt>
                <c:pt idx="2">
                  <c:v>3.0181818181818212</c:v>
                </c:pt>
                <c:pt idx="3">
                  <c:v>2.2549019607843186</c:v>
                </c:pt>
                <c:pt idx="4">
                  <c:v>1.6470588235294121</c:v>
                </c:pt>
              </c:numCache>
            </c:numRef>
          </c:val>
        </c:ser>
        <c:marker val="1"/>
        <c:axId val="82874368"/>
        <c:axId val="84252928"/>
      </c:lineChart>
      <c:catAx>
        <c:axId val="8287436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 baseline="0"/>
                </a:pPr>
                <a:r>
                  <a:rPr lang="en-US" sz="2000" baseline="0" dirty="0"/>
                  <a:t>Weeks after Rotator Cuff Repair</a:t>
                </a:r>
              </a:p>
            </c:rich>
          </c:tx>
          <c:layout>
            <c:manualLayout>
              <c:xMode val="edge"/>
              <c:yMode val="edge"/>
              <c:x val="0.35077073790657581"/>
              <c:y val="0.91987955672207711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 baseline="0"/>
            </a:pPr>
            <a:endParaRPr lang="en-US"/>
          </a:p>
        </c:txPr>
        <c:crossAx val="84252928"/>
        <c:crosses val="autoZero"/>
        <c:auto val="1"/>
        <c:lblAlgn val="ctr"/>
        <c:lblOffset val="100"/>
      </c:catAx>
      <c:valAx>
        <c:axId val="84252928"/>
        <c:scaling>
          <c:orientation val="minMax"/>
          <c:max val="4"/>
        </c:scaling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2000" b="1" i="0" baseline="0" dirty="0"/>
                  <a:t>Difficulty with Overhead </a:t>
                </a:r>
                <a:r>
                  <a:rPr lang="en-AU" sz="2000" b="1" i="0" baseline="0" dirty="0" smtClean="0"/>
                  <a:t>Activities</a:t>
                </a:r>
                <a:endParaRPr lang="en-AU" sz="2000" baseline="0" dirty="0"/>
              </a:p>
            </c:rich>
          </c:tx>
          <c:layout>
            <c:manualLayout>
              <c:xMode val="edge"/>
              <c:yMode val="edge"/>
              <c:x val="4.707514635965631E-2"/>
              <c:y val="0.24596704578594375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crossAx val="82874368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79874455224257601"/>
          <c:y val="0.16419510061242379"/>
          <c:w val="0.13476823983733377"/>
          <c:h val="9.3832020997375531E-2"/>
        </c:manualLayout>
      </c:layout>
      <c:txPr>
        <a:bodyPr/>
        <a:lstStyle/>
        <a:p>
          <a:pPr>
            <a:defRPr sz="1600" baseline="0"/>
          </a:pPr>
          <a:endParaRPr lang="en-US"/>
        </a:p>
      </c:txPr>
    </c:legend>
    <c:plotVisOnly val="1"/>
  </c:chart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51</cdr:x>
      <cdr:y>0.12201</cdr:y>
    </cdr:from>
    <cdr:to>
      <cdr:x>0.22248</cdr:x>
      <cdr:y>0.91991</cdr:y>
    </cdr:to>
    <cdr:grpSp>
      <cdr:nvGrpSpPr>
        <cdr:cNvPr id="9" name="Group 8"/>
        <cdr:cNvGrpSpPr/>
      </cdr:nvGrpSpPr>
      <cdr:grpSpPr>
        <a:xfrm xmlns:a="http://schemas.openxmlformats.org/drawingml/2006/main">
          <a:off x="780255" y="836745"/>
          <a:ext cx="1259593" cy="5471998"/>
          <a:chOff x="5508104" y="980728"/>
          <a:chExt cx="1259632" cy="5400600"/>
        </a:xfrm>
      </cdr:grpSpPr>
      <cdr:sp macro="" textlink="">
        <cdr:nvSpPr>
          <cdr:cNvPr id="10" name="Rectangle 9"/>
          <cdr:cNvSpPr/>
        </cdr:nvSpPr>
        <cdr:spPr>
          <a:xfrm xmlns:a="http://schemas.openxmlformats.org/drawingml/2006/main">
            <a:off x="5508104" y="980728"/>
            <a:ext cx="1112447" cy="5400600"/>
          </a:xfrm>
          <a:prstGeom xmlns:a="http://schemas.openxmlformats.org/drawingml/2006/main" prst="rect">
            <a:avLst/>
          </a:prstGeom>
          <a:solidFill xmlns:a="http://schemas.openxmlformats.org/drawingml/2006/main">
            <a:sysClr val="window" lastClr="FFFFFF"/>
          </a:solidFill>
          <a:ln xmlns:a="http://schemas.openxmlformats.org/drawingml/2006/main" w="25400" cap="flat" cmpd="sng" algn="ctr">
            <a:solidFill>
              <a:sysClr val="window" lastClr="FFFFFF"/>
            </a:solidFill>
            <a:prstDash val="solid"/>
          </a:ln>
          <a:effectLst xmlns:a="http://schemas.openxmlformats.org/drawingml/2006/main"/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11" name="TextBox 2"/>
          <cdr:cNvSpPr txBox="1"/>
        </cdr:nvSpPr>
        <cdr:spPr>
          <a:xfrm xmlns:a="http://schemas.openxmlformats.org/drawingml/2006/main">
            <a:off x="5580112" y="1268760"/>
            <a:ext cx="1150756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Very severe</a:t>
            </a:r>
            <a:endParaRPr lang="en-AU" sz="1600" dirty="0"/>
          </a:p>
        </cdr:txBody>
      </cdr:sp>
      <cdr:sp macro="" textlink="">
        <cdr:nvSpPr>
          <cdr:cNvPr id="12" name="TextBox 3"/>
          <cdr:cNvSpPr txBox="1"/>
        </cdr:nvSpPr>
        <cdr:spPr>
          <a:xfrm xmlns:a="http://schemas.openxmlformats.org/drawingml/2006/main">
            <a:off x="5902721" y="2492896"/>
            <a:ext cx="744303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/>
              <a:t>S</a:t>
            </a:r>
            <a:r>
              <a:rPr lang="en-AU" sz="1600" dirty="0" smtClean="0"/>
              <a:t>evere</a:t>
            </a:r>
            <a:endParaRPr lang="en-AU" sz="1600" dirty="0"/>
          </a:p>
        </cdr:txBody>
      </cdr:sp>
      <cdr:sp macro="" textlink="">
        <cdr:nvSpPr>
          <cdr:cNvPr id="13" name="TextBox 4"/>
          <cdr:cNvSpPr txBox="1"/>
        </cdr:nvSpPr>
        <cdr:spPr>
          <a:xfrm xmlns:a="http://schemas.openxmlformats.org/drawingml/2006/main">
            <a:off x="5759114" y="3573016"/>
            <a:ext cx="1008622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Moderate</a:t>
            </a:r>
            <a:endParaRPr lang="en-AU" sz="1600" dirty="0"/>
          </a:p>
        </cdr:txBody>
      </cdr:sp>
      <cdr:sp macro="" textlink="">
        <cdr:nvSpPr>
          <cdr:cNvPr id="14" name="TextBox 6"/>
          <cdr:cNvSpPr txBox="1"/>
        </cdr:nvSpPr>
        <cdr:spPr>
          <a:xfrm xmlns:a="http://schemas.openxmlformats.org/drawingml/2006/main">
            <a:off x="6118131" y="4725144"/>
            <a:ext cx="558179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Mild</a:t>
            </a:r>
            <a:endParaRPr lang="en-AU" sz="1600" dirty="0"/>
          </a:p>
        </cdr:txBody>
      </cdr:sp>
      <cdr:sp macro="" textlink="">
        <cdr:nvSpPr>
          <cdr:cNvPr id="15" name="TextBox 7"/>
          <cdr:cNvSpPr txBox="1"/>
        </cdr:nvSpPr>
        <cdr:spPr>
          <a:xfrm xmlns:a="http://schemas.openxmlformats.org/drawingml/2006/main">
            <a:off x="6046328" y="5805264"/>
            <a:ext cx="634904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None</a:t>
            </a:r>
            <a:endParaRPr lang="en-AU" sz="1600" dirty="0"/>
          </a:p>
        </cdr:txBody>
      </cdr: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/>
          <p:nvPr/>
        </p:nvGraphicFramePr>
        <p:xfrm>
          <a:off x="0" y="692696"/>
          <a:ext cx="9144000" cy="6165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 12"/>
          <p:cNvGrpSpPr/>
          <p:nvPr/>
        </p:nvGrpSpPr>
        <p:grpSpPr>
          <a:xfrm>
            <a:off x="576064" y="764704"/>
            <a:ext cx="1259632" cy="5472608"/>
            <a:chOff x="1331640" y="908720"/>
            <a:chExt cx="1259632" cy="5400600"/>
          </a:xfrm>
        </p:grpSpPr>
        <p:sp>
          <p:nvSpPr>
            <p:cNvPr id="14" name="Rectangle 13"/>
            <p:cNvSpPr/>
            <p:nvPr/>
          </p:nvSpPr>
          <p:spPr>
            <a:xfrm>
              <a:off x="1331640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403648" y="1196752"/>
              <a:ext cx="11507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Very severe</a:t>
              </a:r>
              <a:endParaRPr lang="en-AU" sz="16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26257" y="2420888"/>
              <a:ext cx="7443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/>
                <a:t>S</a:t>
              </a:r>
              <a:r>
                <a:rPr lang="en-AU" sz="1600" dirty="0" smtClean="0"/>
                <a:t>evere</a:t>
              </a:r>
              <a:endParaRPr lang="en-AU" sz="16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582650" y="3501008"/>
              <a:ext cx="10086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derate</a:t>
              </a:r>
              <a:endParaRPr lang="en-AU" sz="16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941667" y="4653136"/>
              <a:ext cx="5581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ild</a:t>
              </a:r>
              <a:endParaRPr lang="en-AU" sz="16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869864" y="5733256"/>
              <a:ext cx="6349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one</a:t>
              </a:r>
              <a:endParaRPr lang="en-AU" sz="1600" dirty="0"/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2195736" y="5970766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  <p:grpSp>
        <p:nvGrpSpPr>
          <p:cNvPr id="11" name="Group 10"/>
          <p:cNvGrpSpPr/>
          <p:nvPr/>
        </p:nvGrpSpPr>
        <p:grpSpPr>
          <a:xfrm>
            <a:off x="2555776" y="2348880"/>
            <a:ext cx="1440160" cy="144016"/>
            <a:chOff x="3707904" y="3068960"/>
            <a:chExt cx="2736304" cy="144016"/>
          </a:xfrm>
        </p:grpSpPr>
        <p:cxnSp>
          <p:nvCxnSpPr>
            <p:cNvPr id="13" name="Straight Connector 12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Group 20"/>
          <p:cNvGrpSpPr/>
          <p:nvPr/>
        </p:nvGrpSpPr>
        <p:grpSpPr>
          <a:xfrm>
            <a:off x="2555776" y="2060848"/>
            <a:ext cx="2808312" cy="144016"/>
            <a:chOff x="3707904" y="3068960"/>
            <a:chExt cx="2736304" cy="144016"/>
          </a:xfrm>
        </p:grpSpPr>
        <p:cxnSp>
          <p:nvCxnSpPr>
            <p:cNvPr id="22" name="Straight Connector 21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oup 24"/>
          <p:cNvGrpSpPr/>
          <p:nvPr/>
        </p:nvGrpSpPr>
        <p:grpSpPr>
          <a:xfrm>
            <a:off x="2555776" y="1772816"/>
            <a:ext cx="4176464" cy="144016"/>
            <a:chOff x="3707904" y="3068960"/>
            <a:chExt cx="2736304" cy="144016"/>
          </a:xfrm>
        </p:grpSpPr>
        <p:cxnSp>
          <p:nvCxnSpPr>
            <p:cNvPr id="26" name="Straight Connector 25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oup 30"/>
          <p:cNvGrpSpPr/>
          <p:nvPr/>
        </p:nvGrpSpPr>
        <p:grpSpPr>
          <a:xfrm>
            <a:off x="2555776" y="1484784"/>
            <a:ext cx="5544616" cy="144016"/>
            <a:chOff x="3707904" y="3068960"/>
            <a:chExt cx="2736304" cy="144016"/>
          </a:xfrm>
        </p:grpSpPr>
        <p:cxnSp>
          <p:nvCxnSpPr>
            <p:cNvPr id="32" name="Straight Connector 31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Group 34"/>
          <p:cNvGrpSpPr/>
          <p:nvPr/>
        </p:nvGrpSpPr>
        <p:grpSpPr>
          <a:xfrm>
            <a:off x="5436096" y="3068960"/>
            <a:ext cx="1368152" cy="134724"/>
            <a:chOff x="3707904" y="3068960"/>
            <a:chExt cx="2736304" cy="144016"/>
          </a:xfrm>
        </p:grpSpPr>
        <p:cxnSp>
          <p:nvCxnSpPr>
            <p:cNvPr id="36" name="Straight Connector 35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/>
          <p:cNvGrpSpPr/>
          <p:nvPr/>
        </p:nvGrpSpPr>
        <p:grpSpPr>
          <a:xfrm>
            <a:off x="6804248" y="3654316"/>
            <a:ext cx="1440160" cy="144016"/>
            <a:chOff x="3707904" y="3068960"/>
            <a:chExt cx="2736304" cy="144016"/>
          </a:xfrm>
        </p:grpSpPr>
        <p:cxnSp>
          <p:nvCxnSpPr>
            <p:cNvPr id="40" name="Straight Connector 39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TextBox 42"/>
          <p:cNvSpPr txBox="1"/>
          <p:nvPr/>
        </p:nvSpPr>
        <p:spPr>
          <a:xfrm>
            <a:off x="2987824" y="2123564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44" name="TextBox 43"/>
          <p:cNvSpPr txBox="1"/>
          <p:nvPr/>
        </p:nvSpPr>
        <p:spPr>
          <a:xfrm>
            <a:off x="5797877" y="2843644"/>
            <a:ext cx="6463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45" name="TextBox 44"/>
          <p:cNvSpPr txBox="1"/>
          <p:nvPr/>
        </p:nvSpPr>
        <p:spPr>
          <a:xfrm>
            <a:off x="7166029" y="3429000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46" name="TextBox 45"/>
          <p:cNvSpPr txBox="1"/>
          <p:nvPr/>
        </p:nvSpPr>
        <p:spPr>
          <a:xfrm>
            <a:off x="3839870" y="1835532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47" name="TextBox 46"/>
          <p:cNvSpPr txBox="1"/>
          <p:nvPr/>
        </p:nvSpPr>
        <p:spPr>
          <a:xfrm>
            <a:off x="4213701" y="1547500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48" name="TextBox 47"/>
          <p:cNvSpPr txBox="1"/>
          <p:nvPr/>
        </p:nvSpPr>
        <p:spPr>
          <a:xfrm>
            <a:off x="5149805" y="1268760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/>
          <p:nvPr/>
        </p:nvGraphicFramePr>
        <p:xfrm>
          <a:off x="0" y="692696"/>
          <a:ext cx="9144000" cy="6165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3" name="Group 12"/>
          <p:cNvGrpSpPr/>
          <p:nvPr/>
        </p:nvGrpSpPr>
        <p:grpSpPr>
          <a:xfrm>
            <a:off x="576064" y="764704"/>
            <a:ext cx="1259632" cy="5472608"/>
            <a:chOff x="1331640" y="908720"/>
            <a:chExt cx="1259632" cy="5400600"/>
          </a:xfrm>
        </p:grpSpPr>
        <p:sp>
          <p:nvSpPr>
            <p:cNvPr id="14" name="Rectangle 13"/>
            <p:cNvSpPr/>
            <p:nvPr/>
          </p:nvSpPr>
          <p:spPr>
            <a:xfrm>
              <a:off x="1331640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403648" y="1196752"/>
              <a:ext cx="11507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Very severe</a:t>
              </a:r>
              <a:endParaRPr lang="en-AU" sz="16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26257" y="2420888"/>
              <a:ext cx="7443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/>
                <a:t>S</a:t>
              </a:r>
              <a:r>
                <a:rPr lang="en-AU" sz="1600" dirty="0" smtClean="0"/>
                <a:t>evere</a:t>
              </a:r>
              <a:endParaRPr lang="en-AU" sz="16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582650" y="3501008"/>
              <a:ext cx="10086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derate</a:t>
              </a:r>
              <a:endParaRPr lang="en-AU" sz="16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941667" y="4653136"/>
              <a:ext cx="5581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ild</a:t>
              </a:r>
              <a:endParaRPr lang="en-AU" sz="16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869864" y="5733256"/>
              <a:ext cx="6349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one</a:t>
              </a:r>
              <a:endParaRPr lang="en-AU" sz="1600" dirty="0"/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2195736" y="5970766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/>
          <p:nvPr/>
        </p:nvGraphicFramePr>
        <p:xfrm>
          <a:off x="-24681" y="0"/>
          <a:ext cx="9168681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755576" y="620688"/>
            <a:ext cx="1259632" cy="5400600"/>
            <a:chOff x="1331640" y="908720"/>
            <a:chExt cx="1259632" cy="5400600"/>
          </a:xfrm>
        </p:grpSpPr>
        <p:sp>
          <p:nvSpPr>
            <p:cNvPr id="10" name="Rectangle 9"/>
            <p:cNvSpPr/>
            <p:nvPr/>
          </p:nvSpPr>
          <p:spPr>
            <a:xfrm>
              <a:off x="1331640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403648" y="1196752"/>
              <a:ext cx="11507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Very severe</a:t>
              </a:r>
              <a:endParaRPr lang="en-AU" sz="1600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726257" y="2420888"/>
              <a:ext cx="7443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/>
                <a:t>S</a:t>
              </a:r>
              <a:r>
                <a:rPr lang="en-AU" sz="1600" dirty="0" smtClean="0"/>
                <a:t>evere</a:t>
              </a:r>
              <a:endParaRPr lang="en-AU" sz="16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582650" y="3501008"/>
              <a:ext cx="10086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derate</a:t>
              </a:r>
              <a:endParaRPr lang="en-AU" sz="16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941667" y="4653136"/>
              <a:ext cx="5581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ild</a:t>
              </a:r>
              <a:endParaRPr lang="en-AU" sz="16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69864" y="5733256"/>
              <a:ext cx="6349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one</a:t>
              </a:r>
              <a:endParaRPr lang="en-AU" sz="1600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3853292" y="1061120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58</Words>
  <Application>Microsoft Office PowerPoint</Application>
  <PresentationFormat>On-screen Show (4:3)</PresentationFormat>
  <Paragraphs>30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t</dc:creator>
  <cp:lastModifiedBy>Pat</cp:lastModifiedBy>
  <cp:revision>14</cp:revision>
  <dcterms:created xsi:type="dcterms:W3CDTF">2011-11-19T23:44:44Z</dcterms:created>
  <dcterms:modified xsi:type="dcterms:W3CDTF">2012-01-17T00:25:21Z</dcterms:modified>
</cp:coreProperties>
</file>